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BB419C-CD2A-49D6-9242-2B9A94D48B0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8D11395-87FD-4414-80BA-E620FA75C03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34557C-2C0B-4426-8004-D285063E35F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AF7FF8-D987-494D-AEB8-509E8BCD8A5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89BA2E-A850-4BE8-AD16-D4B10FC73F9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463243-60D1-4D81-8DA2-034AD4A2337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F02BB9-62F3-4446-B9BC-21413BEACAF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0B0531-A99D-4DAC-8721-A0DEABA0580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426D4A-BB7D-41BF-887B-A8218DE3C28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7668CE-E68B-4714-8A53-4CC823D86D5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B7E615-F91F-45C1-B09E-04352DF0A0A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E46847-139A-41DF-A9AF-547C6BC2C3A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8EC61083-181B-45EA-AFCC-17B3ECFA27DD}" type="datetime">
              <a:rPr b="0" lang="en-US" sz="1200" spc="-1" strike="noStrike">
                <a:solidFill>
                  <a:srgbClr val="898989"/>
                </a:solidFill>
                <a:latin typeface="Calibri"/>
              </a:rPr>
              <a:t>08/29/26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44CECC27-1F39-4337-9530-E202AD8067AE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1612800" y="1727280"/>
          <a:ext cx="5981760" cy="1701720"/>
        </p:xfrm>
        <a:graphic>
          <a:graphicData uri="http://schemas.openxmlformats.org/drawingml/2006/table">
            <a:tbl>
              <a:tblPr/>
              <a:tblGrid>
                <a:gridCol w="1640160"/>
                <a:gridCol w="2211120"/>
                <a:gridCol w="2130480"/>
              </a:tblGrid>
              <a:tr h="339480"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# of Hybridizations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# of Experiments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41640"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Muscle/heart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346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19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39480"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Liver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111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13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41280"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Nervous system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254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18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39840"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Cell lines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281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Verdana"/>
                        </a:rPr>
                        <a:t>21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2" name="TextBox 2"/>
          <p:cNvSpPr/>
          <p:nvPr/>
        </p:nvSpPr>
        <p:spPr>
          <a:xfrm>
            <a:off x="7051320" y="6248520"/>
            <a:ext cx="1678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Additional File 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12-03T13:39:25Z</dcterms:created>
  <dc:creator>Holly Bradley</dc:creator>
  <dc:description/>
  <dc:language>en-US</dc:language>
  <cp:lastModifiedBy>Holly Bradley</cp:lastModifiedBy>
  <dcterms:modified xsi:type="dcterms:W3CDTF">2010-12-16T15:00:51Z</dcterms:modified>
  <cp:revision>2</cp:revision>
  <dc:subject/>
  <dc:title>Slide 1</dc:title>
</cp:coreProperties>
</file>